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4.jpeg" ContentType="image/jpeg"/>
  <Override PartName="/ppt/media/image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</p:sldIdLst>
  <p:sldSz cx="9144000" cy="6858000"/>
  <p:notesSz cx="6735763" cy="98710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5D2927-83FB-4824-83FE-3A6A7DB4712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0EC95-5CAF-484E-966A-DAF300445F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02A9FD-42A4-4B29-BE81-27D866281E7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04EAAA-CA2F-47FE-A8DD-245EE23406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7B821F-9EC8-4736-90AF-B32ED9450F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B89CE-E884-4348-B9E3-AD158F3674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77400D-A9B3-472A-8449-72B236C530E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686398-6172-4195-8EE6-665D164737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9222B-EDDD-4CC3-8163-CD8169354D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33398-1898-475D-BBD6-580E9F0684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9EFE3-B7FC-4E7B-AB04-013AE6CC06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5BE32-3B2C-4B1E-A28C-8638D265E3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7F54D8-BE3C-41B5-8896-F09FBED75643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image" Target="../media/image4.jpeg"/><Relationship Id="rId8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0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1.pn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6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pn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8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9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1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3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4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5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6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17.png"/><Relationship Id="rId7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8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19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4"/>
          <p:cNvGraphicFramePr/>
          <p:nvPr/>
        </p:nvGraphicFramePr>
        <p:xfrm>
          <a:off x="1763640" y="920880"/>
          <a:ext cx="2467080" cy="1257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63640" y="920880"/>
                    <a:ext cx="2467080" cy="125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5"/>
          <p:cNvGraphicFramePr/>
          <p:nvPr/>
        </p:nvGraphicFramePr>
        <p:xfrm>
          <a:off x="1763640" y="2233440"/>
          <a:ext cx="2533680" cy="1943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763640" y="2233440"/>
                    <a:ext cx="2533680" cy="1943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5" name="Text Box 10"/>
          <p:cNvSpPr/>
          <p:nvPr/>
        </p:nvSpPr>
        <p:spPr>
          <a:xfrm>
            <a:off x="2936520" y="44280"/>
            <a:ext cx="177192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t shock &amp; MG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6" name="Text Box 11"/>
          <p:cNvSpPr/>
          <p:nvPr/>
        </p:nvSpPr>
        <p:spPr>
          <a:xfrm>
            <a:off x="236160" y="961920"/>
            <a:ext cx="1326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mbrane traffic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Text Box 12"/>
          <p:cNvSpPr/>
          <p:nvPr/>
        </p:nvSpPr>
        <p:spPr>
          <a:xfrm>
            <a:off x="234360" y="2276640"/>
            <a:ext cx="125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xidoreduct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8" name="Text Box 5"/>
          <p:cNvSpPr/>
          <p:nvPr/>
        </p:nvSpPr>
        <p:spPr>
          <a:xfrm>
            <a:off x="3960" y="-27000"/>
            <a:ext cx="26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A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4162320" y="907920"/>
            <a:ext cx="6251760" cy="13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daptor-related protein complex 3, sigma 2 subunit (Ap3s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myloid beta (A4) precursor protein-binding, family A, member 3 (Apba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locked early in transport 1 homolog (S. cerevisiae)-like (Bet1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ethylmaleimide sensitive fusion protein attachment protein alpha (Nap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in kinase C and casein kinase substrate in neurons 3 (Pacsin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yntaxin 3 (Stx3), transcript variant A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ynaptotagmin-like 1 (Syt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-golgi network protein (Tgoln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-golgi network protein 2 (Tgoln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acuolar protein sorting 11 (yeast) (Vps1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acuolar protein sorting 18 (yeast) (Vps18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0" name="Rectangle 11"/>
          <p:cNvSpPr/>
          <p:nvPr/>
        </p:nvSpPr>
        <p:spPr>
          <a:xfrm>
            <a:off x="4162320" y="2209680"/>
            <a:ext cx="6035760" cy="2048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dehyde dehydrogenase family 3, subfamily A1 (Aldh3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poptosis-inducing factor (AIF)-like mitochondrion-associated inducer of death (Amid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mine oxidase, copper containing 2 (retina-specific) (Aoc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ranched chain ketoacid dehydrogenase E1, alpha polypeptide (Bckdh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rbonyl reductase 3 (Cbr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chrome P450, family 26, subfamily b, polypeptide 1 (Cyp26b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ehydrogenase/reductase (SDR family) member 8 (Dhrs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cose-6-phosphate dehydrogenase X-linked (G6pdx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ycerol-3-phosphate dehydrogenase 1 (soluble) (Gp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eme oxygenase (decycling) 1 (Hmox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rbitol dehydrogenase 1 (Sdh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strin 2 (Sesn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permine oxidase (Smox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permine oxidase (Smox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ulfite oxidase (Suox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ioredoxin-like 1 (Txnl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esicle amine transport protein 1 homolog (T californica) (Va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51" name="Object 6"/>
          <p:cNvGraphicFramePr/>
          <p:nvPr/>
        </p:nvGraphicFramePr>
        <p:xfrm>
          <a:off x="1763640" y="4226040"/>
          <a:ext cx="2467080" cy="24001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52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763640" y="4226040"/>
                    <a:ext cx="2467080" cy="240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3" name="Text Box 13"/>
          <p:cNvSpPr/>
          <p:nvPr/>
        </p:nvSpPr>
        <p:spPr>
          <a:xfrm>
            <a:off x="232560" y="4230720"/>
            <a:ext cx="146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gnaling molecul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4" name="Rectangle 14"/>
          <p:cNvSpPr/>
          <p:nvPr/>
        </p:nvSpPr>
        <p:spPr>
          <a:xfrm>
            <a:off x="4162320" y="4211640"/>
            <a:ext cx="5143680" cy="252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giopoietin 2 (Agpt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giopoietin-like 6 (Angpt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mphiregulin (Areg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iliary neurotrophic factor (Cntf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iliary neurotrophic factor (Cntf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nnective tissue growth factor (Ctgf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emokine (C-X-C motif) ligand 1 (Cxc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steine rich protein 61 (Cyr6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steine rich protein 61 (Cyr6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own syndrome critical region homolog 1 (human) (Dscr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own syndrome critical region homolog 1 (human) (Dscr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-box only protein 23 (Fbxo2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ial cell line derived neurotrophic factor (Gdnf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ukemia inhibitory factor (Lif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RCKS-like protein (Ml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euroligin 2 (Nlgn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liferin (Plf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tanniocalcin 2 (Stc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forming growth factor, beta 2 (Tgfb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 receptor-associated factor 6 (Traf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ascular endothelial growth factor A (Vegf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5" name="TextBox 7"/>
          <p:cNvSpPr/>
          <p:nvPr/>
        </p:nvSpPr>
        <p:spPr>
          <a:xfrm rot="16200000">
            <a:off x="2470320" y="-216000"/>
            <a:ext cx="395280" cy="180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66ff"/>
                </a:solidFill>
                <a:latin typeface="Arial"/>
                <a:ea typeface="맑은 고딕"/>
              </a:rPr>
              <a:t>RH 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66ff"/>
                </a:solidFill>
                <a:latin typeface="Arial"/>
                <a:ea typeface="맑은 고딕"/>
              </a:rPr>
              <a:t>RH 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66ff"/>
                </a:solidFill>
                <a:latin typeface="Arial"/>
                <a:ea typeface="맑은 고딕"/>
              </a:rPr>
              <a:t>RH 3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66ff"/>
                </a:solidFill>
                <a:latin typeface="Arial"/>
                <a:ea typeface="맑은 고딕"/>
              </a:rPr>
              <a:t>RH 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맑은 고딕"/>
              </a:rPr>
              <a:t>TH 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맑은 고딕"/>
              </a:rPr>
              <a:t>TH 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맑은 고딕"/>
              </a:rPr>
              <a:t>TH 3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Arial"/>
                <a:ea typeface="맑은 고딕"/>
              </a:rPr>
              <a:t>TH 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cc00"/>
                </a:solidFill>
                <a:latin typeface="Arial"/>
                <a:ea typeface="맑은 고딕"/>
              </a:rPr>
              <a:t>RM 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cc00"/>
                </a:solidFill>
                <a:latin typeface="Arial"/>
                <a:ea typeface="맑은 고딕"/>
              </a:rPr>
              <a:t>RM 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cc00"/>
                </a:solidFill>
                <a:latin typeface="Arial"/>
                <a:ea typeface="맑은 고딕"/>
              </a:rPr>
              <a:t>RM 3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cc00"/>
                </a:solidFill>
                <a:latin typeface="Arial"/>
                <a:ea typeface="맑은 고딕"/>
              </a:rPr>
              <a:t>RM 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9900"/>
                </a:solidFill>
                <a:latin typeface="Arial"/>
                <a:ea typeface="맑은 고딕"/>
              </a:rPr>
              <a:t>TM 1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9900"/>
                </a:solidFill>
                <a:latin typeface="Arial"/>
                <a:ea typeface="맑은 고딕"/>
              </a:rPr>
              <a:t>TM 2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9900"/>
                </a:solidFill>
                <a:latin typeface="Arial"/>
                <a:ea typeface="맑은 고딕"/>
              </a:rPr>
              <a:t>TM 3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9900"/>
                </a:solidFill>
                <a:latin typeface="Arial"/>
                <a:ea typeface="맑은 고딕"/>
              </a:rPr>
              <a:t>TM 4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6" name="TextBox 7"/>
          <p:cNvSpPr/>
          <p:nvPr/>
        </p:nvSpPr>
        <p:spPr>
          <a:xfrm rot="16200000">
            <a:off x="3567960" y="632160"/>
            <a:ext cx="393840" cy="113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맑은 고딕"/>
              </a:rPr>
              <a:t>T/R</a:t>
            </a:r>
            <a:endParaRPr b="0" lang="en-US" sz="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7" name="Text Box 48"/>
          <p:cNvSpPr/>
          <p:nvPr/>
        </p:nvSpPr>
        <p:spPr>
          <a:xfrm>
            <a:off x="179280" y="6524640"/>
            <a:ext cx="1368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&lt;-10       fold      10&lt;</a:t>
            </a:r>
            <a:endParaRPr b="0" lang="en-US" sz="6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8" name="Picture 6" descr="total_max10"/>
          <p:cNvPicPr/>
          <p:nvPr/>
        </p:nvPicPr>
        <p:blipFill>
          <a:blip r:embed="rId7"/>
          <a:srcRect l="363" t="13843" r="2179" b="83890"/>
          <a:stretch/>
        </p:blipFill>
        <p:spPr>
          <a:xfrm>
            <a:off x="258840" y="6469200"/>
            <a:ext cx="690480" cy="871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Text Box 12"/>
          <p:cNvSpPr/>
          <p:nvPr/>
        </p:nvSpPr>
        <p:spPr>
          <a:xfrm>
            <a:off x="319680" y="981000"/>
            <a:ext cx="74916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fe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arrie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6" name="Text Box 13"/>
          <p:cNvSpPr/>
          <p:nvPr/>
        </p:nvSpPr>
        <p:spPr>
          <a:xfrm>
            <a:off x="178920" y="2327400"/>
            <a:ext cx="99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fer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137" name="Object 15"/>
          <p:cNvGraphicFramePr/>
          <p:nvPr/>
        </p:nvGraphicFramePr>
        <p:xfrm>
          <a:off x="1273320" y="933480"/>
          <a:ext cx="2762280" cy="1257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8" name="Object 1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73320" y="933480"/>
                    <a:ext cx="2762280" cy="1257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39" name="Object 17"/>
          <p:cNvGraphicFramePr/>
          <p:nvPr/>
        </p:nvGraphicFramePr>
        <p:xfrm>
          <a:off x="1273320" y="2301840"/>
          <a:ext cx="2562120" cy="2971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40" name="Object 17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273320" y="2301840"/>
                    <a:ext cx="2562120" cy="2971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1" name="Text Box 15"/>
          <p:cNvSpPr/>
          <p:nvPr/>
        </p:nvSpPr>
        <p:spPr>
          <a:xfrm>
            <a:off x="3355560" y="18900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2" name="Rectangle 10"/>
          <p:cNvSpPr/>
          <p:nvPr/>
        </p:nvSpPr>
        <p:spPr>
          <a:xfrm>
            <a:off x="4081320" y="900000"/>
            <a:ext cx="6683400" cy="133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nexin A4 (Anxa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nexin A8 (Anxa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KEN cDNA E430025E21 gene (E430025E21Ri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atty acid binding protein 3, muscle and heart (Fabp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nnose-6-phosphate receptor binding protein 1 (M6prb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5, member 33 (Slc25a25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5 (mitochondrial carrier; phosphate carrier), member 26 (Slc25a2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5, member 33 (Slc25a33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5, member 44 (Slc25a44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tAR-related lipid transfer (START) domain containing 5 (Stard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tAR-related lipid transfer (START) domain containing 5 (Stard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3" name="Rectangle 11"/>
          <p:cNvSpPr/>
          <p:nvPr/>
        </p:nvSpPr>
        <p:spPr>
          <a:xfrm>
            <a:off x="4095720" y="2263680"/>
            <a:ext cx="6251760" cy="3120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DP-ribosyltransferase (NAD+; poly (ADP-ribose polymerase)-like 3 (Adprtl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rginine-tRNA-protein transferase 1 (Ate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DNA sequence BC036718 (BC03671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ranched chain aminotransferase 1, cytosolic (Bca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rnitine palmitoyltransferase 2 (Cpt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rnitine acetyltransferase (Crat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rdiolipin synthase 1 (Crls1), transcript variant 2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iacylglycerol O-acyltransferase 2 (Dgat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acetylglucosamine-1-phosphotransferase, gamma subunit (Gnptg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acetylglucosamine-2-phosphotransferase, gamma subunit (Gnptg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mu 1 (Gstm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mu 6 (Gstm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theta 3 (Gstt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ike-glycosyltransferase (Large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ionine adenosyltransferase II, alpha (Mat2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ionine adenosyltransferase II, alpha (Mat2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ionine adenosyltransferase II, alpha (Mat2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icotinate phosphoribosyltransferase domain containing 1 (Naprt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tatin-like phospholipase domain containing 2 (Pnpla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aldolase 1 (Taldo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NA methyltransferase 61 homolog A (S. cerevisiae) (Trmt61a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-N-acetylglucosamine pyrophosphorylase 1 (Ua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 glycosyltransferase 1 family, polypeptide A6 (Ugt1a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 glucuronosyltransferase 1 family, polypeptide A6B (Ugt1a6b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 glucuronosyltransferase 1 family, polypeptide A6B (Ugt1a6b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 glucuronosyltransferase 1 family, polypeptide A7C (Ugt1a7c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4" name="Text Box 5"/>
          <p:cNvSpPr/>
          <p:nvPr/>
        </p:nvSpPr>
        <p:spPr>
          <a:xfrm>
            <a:off x="4320" y="10800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 Box 14"/>
          <p:cNvSpPr/>
          <p:nvPr/>
        </p:nvSpPr>
        <p:spPr>
          <a:xfrm>
            <a:off x="0" y="2637000"/>
            <a:ext cx="97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porte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146" name="Object 16"/>
          <p:cNvGraphicFramePr/>
          <p:nvPr/>
        </p:nvGraphicFramePr>
        <p:xfrm>
          <a:off x="1163520" y="2629080"/>
          <a:ext cx="2552760" cy="2400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47" name="Object 1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63520" y="2629080"/>
                    <a:ext cx="2552760" cy="240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48" name="Rectangle 6"/>
          <p:cNvSpPr/>
          <p:nvPr/>
        </p:nvSpPr>
        <p:spPr>
          <a:xfrm>
            <a:off x="3995640" y="2637000"/>
            <a:ext cx="6121440" cy="252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A (ABC1), member 2 (Abc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B (MDR/TAP), member 6 (Abcb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D (ALD), member 1 (Abc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F (GCN20), member 2 (Abcf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F (GCN20), member 2 (Abcf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lysosomal V0 subunit a isoform 1 (Atp6v0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0 subunit B (Atp6v0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1 subunit E isoform 1 (Atp6v1e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1 subunit F (Atp6v1f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AN binding protein 9 (Ranbp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ideroflexin 4 (Sfxn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19 (sodium/hydrogen exchanger), member 1 (Slc19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4 (sodium/potassium/calcium exchanger), member 3 (Slc24a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 (facilitated glucose transporter), member 6 (Slc2a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30 (zinc transporter), member 1 (Slc30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6 (neurotransmitter transporter, creatine), member 8 (Slc6a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7 (cationic amino acid transporter, y+ system), member 11 (Slc7a1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porter 1, ATP-binding cassette, sub-family B (MDR/TAP) (Ta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porter 2, ATP-binding cassette, sub-family B (MDR/TAP) (Tap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-cell, immune regulator 1 (Tcirg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-cell, immune regulator 1 (Tcirg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49" name="Text Box 15"/>
          <p:cNvSpPr/>
          <p:nvPr/>
        </p:nvSpPr>
        <p:spPr>
          <a:xfrm>
            <a:off x="3211200" y="18900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0" name="Text Box 5"/>
          <p:cNvSpPr/>
          <p:nvPr/>
        </p:nvSpPr>
        <p:spPr>
          <a:xfrm>
            <a:off x="4320" y="10800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Text Box 10"/>
          <p:cNvSpPr/>
          <p:nvPr/>
        </p:nvSpPr>
        <p:spPr>
          <a:xfrm>
            <a:off x="2995200" y="44280"/>
            <a:ext cx="177192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t shock &amp; MG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0" name="Text Box 5"/>
          <p:cNvSpPr/>
          <p:nvPr/>
        </p:nvSpPr>
        <p:spPr>
          <a:xfrm>
            <a:off x="3960" y="-27000"/>
            <a:ext cx="26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A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61" name="Object 4"/>
          <p:cNvGraphicFramePr/>
          <p:nvPr/>
        </p:nvGraphicFramePr>
        <p:xfrm>
          <a:off x="1332000" y="473040"/>
          <a:ext cx="2476440" cy="44578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2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32000" y="473040"/>
                    <a:ext cx="2476440" cy="4457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3" name="Object 5"/>
          <p:cNvGraphicFramePr/>
          <p:nvPr/>
        </p:nvGraphicFramePr>
        <p:xfrm>
          <a:off x="1332000" y="4987800"/>
          <a:ext cx="2771640" cy="18288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4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332000" y="4987800"/>
                    <a:ext cx="2771640" cy="1828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5" name="Text Box 7"/>
          <p:cNvSpPr/>
          <p:nvPr/>
        </p:nvSpPr>
        <p:spPr>
          <a:xfrm>
            <a:off x="53640" y="476280"/>
            <a:ext cx="1063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criptio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facto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6" name="Text Box 8"/>
          <p:cNvSpPr/>
          <p:nvPr/>
        </p:nvSpPr>
        <p:spPr>
          <a:xfrm>
            <a:off x="120240" y="5013360"/>
            <a:ext cx="996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fer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7" name="Rectangle 10"/>
          <p:cNvSpPr/>
          <p:nvPr/>
        </p:nvSpPr>
        <p:spPr>
          <a:xfrm>
            <a:off x="4010040" y="449280"/>
            <a:ext cx="6394320" cy="46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E binding protein 2 (Aebp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TB and CNC homology 1 (Bach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asic helix-loop-helix domain containing, class B2 (Bhlhb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asic transcription element binding protein 1 (Bteb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CAAT/enhancer binding protein (C/EBP), beta (Cebp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bp/p300-interacting transactivator, with Glu/Asp-rich carboxy-terminal domain, 2 (Cited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re promoter element binding protein (Cope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re promoter element binding protein (Cope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ofactor required for Sp1 transcriptional activation, subunit 7 (Crsp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 site albumin promoter binding protein (Db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A repeat binding protein, beta 1 (Gabpb1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ATA binding protein 6 (Gata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IS family zinc finger 1 (Glis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igh mobility group box transcription factor 1 (Hb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igh mobility group box transcription factor 1 (Hb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hibitor of growth family, member 4 (Ing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Jun-B oncogene (Jun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ruppel-like factor 4 (gut) (Klf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ruppel-like factor 4 (gut) (Klf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ruppel-like factor 5 (Klf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-maf musculoaponeurotic fibrosarcoma oncogene family, protein F (avian) (Maff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-maf musculoaponeurotic fibrosarcoma oncogene family, protein G (avian) (Mafg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uclear factor, interleukin 3, regulated (Nfil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eckstrin homology domain containing, family F (with FYVE domain) member 2 (Plekhf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OU domain, class 6, transcription factor 1 (Pou6f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ng finger protein 4 (Rnf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NA-binding region (RNP1, RRM) containing 1 (Rnpc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NA-binding region (RNP1, RRM) containing 1 (Rnpc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NG1 and YY1 binding protein (Ryb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RY-box containing gene 4 (Sox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RY-box containing gene 9 (Sox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AF15 RNA polymerase II, TATA box binding protein (TBP)-associated factor (Taf1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cription elongation factor A (SII), 3 (Tcea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EA domain family member 4 (Tead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ducin-like enhancer of split 6, homolog of Drosophila E(spl) (Tle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162 (Zfp16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219 (Zfp21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715 (Zfp715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99 (Zfp9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8" name="Rectangle 11"/>
          <p:cNvSpPr/>
          <p:nvPr/>
        </p:nvSpPr>
        <p:spPr>
          <a:xfrm>
            <a:off x="4025880" y="4989600"/>
            <a:ext cx="5472000" cy="192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-acylglycerol-3-phosphate O-acyltransferase 9 (Agpat9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-acylglycerol-3-phosphate O-acyltransferase 9 (Agpat9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mine fructose-6-phosphate transaminase 2 (Gfpt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mic pyruvic transaminase 1, soluble (Gp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mic pyruvate transaminase (alanine aminotransferase) 2 (Gpt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alpha 4 (Gsta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pi 1 (Gst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S-transferase, pi 1 (Gst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yltransferase like 6 (Mettl6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hyltransferase like 7B (Mettl7b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urine-nucleoside phosphorylase (Pn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in arginine N-methyltransferase 6 (Prmt6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permidine/spermine N1-acetyl transferase 1 (Sa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maF cytoplasmic domain associated protein 2 (Semcap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illiams Beuren syndrome chromosome region 27 (human) (Wbscr27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KEN cDNA 4631426J05 gene (4631426J05Ri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9" name="Object 6"/>
          <p:cNvGraphicFramePr/>
          <p:nvPr/>
        </p:nvGraphicFramePr>
        <p:xfrm>
          <a:off x="971640" y="2421000"/>
          <a:ext cx="2533680" cy="2171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0" name="Object 6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71640" y="2421000"/>
                    <a:ext cx="2533680" cy="2171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1" name="Text Box 9"/>
          <p:cNvSpPr/>
          <p:nvPr/>
        </p:nvSpPr>
        <p:spPr>
          <a:xfrm>
            <a:off x="0" y="2421000"/>
            <a:ext cx="97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porte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Rectangle 6"/>
          <p:cNvSpPr/>
          <p:nvPr/>
        </p:nvSpPr>
        <p:spPr>
          <a:xfrm>
            <a:off x="3659040" y="2416320"/>
            <a:ext cx="5113440" cy="228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A (ABC1), member 7 (Abca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-binding cassette, sub-family G (WHITE), member 1 (Abcg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polipoprotein L 9a (Apol9a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polipoprotein L 9b (Apol9b), transcript variant 2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0 subunit D isoform 1 (Atp6v0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0 subunit D isoform 1 (Atp6v0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0 subunit D isoform 1 (Atp6v0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Pase, H+ transporting, V1 subunit D (Atp6v1d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aC, cation transport regulator-like 1 (E. coli) (Chac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stinosis, nephropathic (Ctn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12, member 6 (Slc12a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16 (monocarboxylic acid transporters), member 9 (Slc16a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19 (thiamine transporter), member 2 (Slc19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1 (glutamate/neutral amino acid transporter), member 4 (Slc1a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3 (nucleobase transporters), member 3 (Slc23a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4 (sodium/potassium/calcium exchanger), member 6 (Slc24a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27 (fatty acid transporter), member 1 (Slc27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lute carrier family 6 (neurotransmitter transporter, glycine), member 9 (Slc6a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pinster homolog 1 (Drosophila) (Spns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Text Box 10"/>
          <p:cNvSpPr/>
          <p:nvPr/>
        </p:nvSpPr>
        <p:spPr>
          <a:xfrm>
            <a:off x="3066840" y="115920"/>
            <a:ext cx="177192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t shock &amp; MG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Text Box 5"/>
          <p:cNvSpPr/>
          <p:nvPr/>
        </p:nvSpPr>
        <p:spPr>
          <a:xfrm>
            <a:off x="3960" y="108000"/>
            <a:ext cx="26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A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5" name="Object 4"/>
          <p:cNvGraphicFramePr/>
          <p:nvPr/>
        </p:nvGraphicFramePr>
        <p:xfrm>
          <a:off x="971640" y="1058760"/>
          <a:ext cx="2743200" cy="6858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76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971640" y="1058760"/>
                    <a:ext cx="2743200" cy="685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7" name="Object 5"/>
          <p:cNvGraphicFramePr/>
          <p:nvPr/>
        </p:nvGraphicFramePr>
        <p:xfrm>
          <a:off x="971640" y="1785960"/>
          <a:ext cx="2752560" cy="16002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78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971640" y="1785960"/>
                    <a:ext cx="2752560" cy="1600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9" name="Object 6"/>
          <p:cNvGraphicFramePr/>
          <p:nvPr/>
        </p:nvGraphicFramePr>
        <p:xfrm>
          <a:off x="971640" y="3443400"/>
          <a:ext cx="2523960" cy="18288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80" name="Object 6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971640" y="3443400"/>
                    <a:ext cx="2523960" cy="1828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1" name="Text Box 8"/>
          <p:cNvSpPr/>
          <p:nvPr/>
        </p:nvSpPr>
        <p:spPr>
          <a:xfrm>
            <a:off x="3065400" y="130320"/>
            <a:ext cx="119736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t shock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Text Box 9"/>
          <p:cNvSpPr/>
          <p:nvPr/>
        </p:nvSpPr>
        <p:spPr>
          <a:xfrm>
            <a:off x="-720" y="1047600"/>
            <a:ext cx="1020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xtracellula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atrix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 Box 10"/>
          <p:cNvSpPr/>
          <p:nvPr/>
        </p:nvSpPr>
        <p:spPr>
          <a:xfrm>
            <a:off x="178920" y="179244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in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Text Box 11"/>
          <p:cNvSpPr/>
          <p:nvPr/>
        </p:nvSpPr>
        <p:spPr>
          <a:xfrm>
            <a:off x="106200" y="3448080"/>
            <a:ext cx="81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gnaling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olecul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Text Box 5"/>
          <p:cNvSpPr/>
          <p:nvPr/>
        </p:nvSpPr>
        <p:spPr>
          <a:xfrm>
            <a:off x="3960" y="108000"/>
            <a:ext cx="26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B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Rectangle 12"/>
          <p:cNvSpPr/>
          <p:nvPr/>
        </p:nvSpPr>
        <p:spPr>
          <a:xfrm>
            <a:off x="3635280" y="1047600"/>
            <a:ext cx="3429000" cy="73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ngiopoietin-like 4 (Angptl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trilin 4 (Matn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ultimerin 2 (Mmrn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sothelin-like (Mslnl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etrin 3 (Ntn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KEN cDNA 1700051I12 gene (1700051I12Ri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Rectangle 13"/>
          <p:cNvSpPr/>
          <p:nvPr/>
        </p:nvSpPr>
        <p:spPr>
          <a:xfrm>
            <a:off x="3635280" y="1768320"/>
            <a:ext cx="3861000" cy="1690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denylate kinase 4 (Ak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ymoma viral proto-oncogene 3 (Akt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ell division cycle 2-like 6 (CDK8-like) (Cdc2l6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reatine kinase, brain (Ck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eline sarcoma oncogene (Fe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gen activated protein kinase kinase kinase 12 (Map3k1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P kinase-interacting serine/threonine kinase 2 (Mkn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UAK family, SNF1-like kinase, 2 (Nuak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yruvate dehydrogenase kinase, isoenzyme 1 (Pdk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osphofructokinase, liver, B-type (Pfk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rum/glucocorticoid regulated kinase (Sg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rting nexin 16 (Snx1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rine/threonine protein kinase SSTK (Sst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KEN cDNA E030030I06 gene (E030030I06Ri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Rectangle 14"/>
          <p:cNvSpPr/>
          <p:nvPr/>
        </p:nvSpPr>
        <p:spPr>
          <a:xfrm>
            <a:off x="3622680" y="3422520"/>
            <a:ext cx="7284960" cy="1929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cl2-like 1 (Bcl2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etacellulin, epidermal growth factor family member (Btc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own syndrome critical region gene 1-like 2 (Dscr1l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iphtheria toxin receptor (Dtr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ndothelin 1 (Edn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ngulfment and cell motility 2, ced-12 homolog (C. elegans) (Elmo2), transcript variant 3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rowth differentiation factor 1 (Gdf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rowth differentiation factor 9 (Gdf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hrelin (Ghr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ymphocyte specific 1 (Ls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RCKS-like protein (Ml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atelet derived growth factor, alpha (Pdgf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rathyroid hormone-like peptide (Pthlh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yndecan 1 (Sdc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sema domain, immunoglobulin domain (Ig), transmembrane domain (TM) and short cytoplasmic domain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ingless related MMTV integration site 10b (Wnt10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9" name="Object 7"/>
          <p:cNvGraphicFramePr/>
          <p:nvPr/>
        </p:nvGraphicFramePr>
        <p:xfrm>
          <a:off x="1644480" y="1287360"/>
          <a:ext cx="2514600" cy="38862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0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644480" y="1287360"/>
                    <a:ext cx="2514600" cy="388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1" name="Text Box 12"/>
          <p:cNvSpPr/>
          <p:nvPr/>
        </p:nvSpPr>
        <p:spPr>
          <a:xfrm>
            <a:off x="106920" y="1353960"/>
            <a:ext cx="148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nscription factor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Rectangle 6"/>
          <p:cNvSpPr/>
          <p:nvPr/>
        </p:nvSpPr>
        <p:spPr>
          <a:xfrm>
            <a:off x="4284720" y="1268280"/>
            <a:ext cx="5256000" cy="407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clin L1 (Ccn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clin T1 (Ccn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istal-less homeobox 2 (Dlx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arly growth response 1 (Egr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ts variant gene 1 (Etv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BJ osteosarcoma oncogene (Fo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BJ osteosarcoma oncogene B (Fos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s-like antigen 1 (Fos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rkhead box D4 (Foxd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rkhead box F1a (Foxf1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rkhead box K1 (Foxk1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orkhead box Q1 (Foxq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A repeat binding protein, beta 1 (Gabpb1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airy and enhancer of split 1 (Drosophila) (Hes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ypermethylated in cancer 1 (Hic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omeo box C13 (Hoxc1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omeo box C9 (Hoxc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hibitor of DNA binding 1 (Idb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hibitor of DNA binding 3 (Idb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Jun oncogene (Jun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omeo box, msh-like 1 (Msx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al response element binding transcription factor 1 (Mtf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uclear receptor coactivator 1 (Nco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D homolog 3 (Drosophila) (Smad3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AR DNA binding protein (Tardb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-box 3 (Tbx3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anscription factor AP-2, alpha (Tcfap2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W domain containing transcription regulator 1 (Wwtr1), transcript variant 2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, CCHC domain containing 3 (Zcchc4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, CCHC domain containing 3 (Zcchc3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385 (Zfp38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41 (Zfp4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 protein 623 (Zfp623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zinc fingers and homeoboxes protein 1 (Zhx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Text Box 8"/>
          <p:cNvSpPr/>
          <p:nvPr/>
        </p:nvSpPr>
        <p:spPr>
          <a:xfrm>
            <a:off x="3209760" y="189000"/>
            <a:ext cx="119736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eat shock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Text Box 5"/>
          <p:cNvSpPr/>
          <p:nvPr/>
        </p:nvSpPr>
        <p:spPr>
          <a:xfrm>
            <a:off x="3960" y="108000"/>
            <a:ext cx="2626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B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5" name="Object 4"/>
          <p:cNvGraphicFramePr/>
          <p:nvPr/>
        </p:nvGraphicFramePr>
        <p:xfrm>
          <a:off x="1201680" y="1001880"/>
          <a:ext cx="2524320" cy="4686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96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01680" y="1001880"/>
                    <a:ext cx="2524320" cy="4686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7" name="Text Box 15"/>
          <p:cNvSpPr/>
          <p:nvPr/>
        </p:nvSpPr>
        <p:spPr>
          <a:xfrm>
            <a:off x="3139560" y="18900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 Box 16"/>
          <p:cNvSpPr/>
          <p:nvPr/>
        </p:nvSpPr>
        <p:spPr>
          <a:xfrm>
            <a:off x="65160" y="1052640"/>
            <a:ext cx="960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tei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tabolism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Text Box 5"/>
          <p:cNvSpPr/>
          <p:nvPr/>
        </p:nvSpPr>
        <p:spPr>
          <a:xfrm>
            <a:off x="4320" y="11592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Rectangle 8"/>
          <p:cNvSpPr/>
          <p:nvPr/>
        </p:nvSpPr>
        <p:spPr>
          <a:xfrm>
            <a:off x="3794040" y="958680"/>
            <a:ext cx="5818320" cy="4908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HA1, activator of heat shock 90kDa protein ATPase homolog 1 (yeast) (Ahs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HA1, activator of heat shock protein ATPase homolog 2 (yeast) (Ahsa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cylpeptide hydrolase (Apeh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xpressed sequence AV006891 (AV00689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lcium binding protein, intestinal (Cai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lcium/calmodulin-dependent protein kinase I (Camk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naJ (Hsp40) homolog, subfamily A, member 2 (Dnaj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naJ (Hsp40) homolog, subfamily B, member 10 (Dnajb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olichyl pyrophosphate phosphatase 1 (Dolp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ukaryotic translation initiation factor 2B, subunit 4 delta (Eif2b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mate-cysteine ligase , modifier subunit (Gclm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acetylglucosamine-1-phosphotransferase, gamma subunit (Gnptg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acetylglucosamine-1-phosphotransferase, gamma subunit (Gnptg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TP binding protein 4 (Gtpbp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eat shock 70kD protein 5 (glucose-regulated protein) (Hspa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eat shock protein 1 (chaperonin) (Hsp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terleukin-1 receptor-associated kinase 2 (Ira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ucyl-tRNA synthetase, mitochondrial (Lars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IM-domain containing, protein kinase (Limk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nnosidase, beta A, lysosomal (Manb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gen activated protein kinase 9 (Mapk9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gen activated protein kinase 9 (Mapk9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mbrane protein, palmitoylated (Mp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chondrial ribosomal protein S18A (Mrps18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sparaginyl-tRNA synthetase (Nar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procollagen-proline, 2-oxoglutarate 4-dioxygenase (proline 4-hydroxylase), alpha II polypeptide (P4h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procollagen lysine, 2-oxoglutarate 5-dioxygenase 2 (Plod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in kinase, interferon-inducible double stranded RNA dependent (Prkr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non-ATPase, 14 (Psmd1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ptidyl-tRNA hydrolase 1 homolog (S. cerevisiae) (Ptrh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ceptor (TNFRSF)-interacting serine-threonine kinase 2 (Rip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ng finger protein 31 (Rnf3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rine/threonine kinase 10 (Stk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rsin family 3, member A (Tor3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rsin family 3, member A (Tor3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rsin family 3, member A (Tor3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NA methyltransferase 61 homolog A (S. cerevisiae) (Trmt61a), transcript variant 1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DP-N-acetylglucosamine pyrophosphorylase 1 (Ua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activating enzyme E1-like (Ube1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conjugating enzyme E2L 6 (Ube2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conjugating enzyme E2L 6 (Ube2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1" name="Object 5"/>
          <p:cNvGraphicFramePr/>
          <p:nvPr/>
        </p:nvGraphicFramePr>
        <p:xfrm>
          <a:off x="1052640" y="870120"/>
          <a:ext cx="2485800" cy="2400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02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052640" y="870120"/>
                    <a:ext cx="2485800" cy="240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3" name="Text Box 17"/>
          <p:cNvSpPr/>
          <p:nvPr/>
        </p:nvSpPr>
        <p:spPr>
          <a:xfrm>
            <a:off x="-360" y="836640"/>
            <a:ext cx="867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ydrol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Rectangle 6"/>
          <p:cNvSpPr/>
          <p:nvPr/>
        </p:nvSpPr>
        <p:spPr>
          <a:xfrm>
            <a:off x="3635280" y="836640"/>
            <a:ext cx="5400720" cy="2572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rylsulfatase A (Ars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laC homolog 2 (E. coli) (Elac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sterase D/formylglutathione hydrolase (Esd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umarylacetoacetate hydrolase domain containing 1 (Fahd1), nuclear gene encoding mitochondrial protein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cosidase, alpha, acid (Ga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TP cyclohydrolase 1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TP cyclohydrolase 1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alactosidase, beta 1 (Glb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cosamine-6-phosphate deaminase 1 (Gnpda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cosamine (N-acetyl)-6-sulfatase (Gn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ydroxyacyl glutathione hydrolase (Hagh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exosaminidase A (Hex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annosidase, beta A, lysosomal (Manb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allo-beta-lactamase domain containing 2 (Mblac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5-nucleotidase, cytosolic III (Nt5c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ospholipase A2, group VI (Pla2g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ospholipase D3 (Pld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ATPase, 4 (Psmc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e (prosome, macropain) 26S subunit, ATPase 5 (Psmc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e (prosome, macropain) 26S subunit, ATPase 5 (Psmc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ptidyl-tRNA hydrolase 1 homolog (S. cerevisiae) (Ptrh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graphicFrame>
        <p:nvGraphicFramePr>
          <p:cNvPr id="105" name="Object 4"/>
          <p:cNvGraphicFramePr/>
          <p:nvPr/>
        </p:nvGraphicFramePr>
        <p:xfrm>
          <a:off x="1042920" y="3359160"/>
          <a:ext cx="2533680" cy="2171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06" name="Object 4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042920" y="3359160"/>
                    <a:ext cx="2533680" cy="2171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07" name="Text Box 10"/>
          <p:cNvSpPr/>
          <p:nvPr/>
        </p:nvSpPr>
        <p:spPr>
          <a:xfrm>
            <a:off x="250560" y="3357720"/>
            <a:ext cx="64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Kin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Rectangle 9"/>
          <p:cNvSpPr/>
          <p:nvPr/>
        </p:nvSpPr>
        <p:spPr>
          <a:xfrm>
            <a:off x="3564000" y="3357720"/>
            <a:ext cx="5817960" cy="228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TM interactor (Atmin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xpressed sequence AV006891 (AV00689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alcium/calmodulin-dependent protein kinase I (Camk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yn proto-oncogene (Fyn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ycerol kinase (Gyk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exokinase 2 (H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ositol hexaphosphate kinase 1 (Ihpk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IM-domain containing, protein kinase (Limk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gen activated protein kinase 9 (Mapk9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itogen activated protein kinase 9 (Mapk9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mbrane protein, palmitoylated (Mp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ntothenate kinase 3 (Pank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osphatidylinositol 4-kinase type 2 beta (Pi4k2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in kinase, interferon-inducible double stranded RNA dependent (Prkr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O kinase 3 (yeast) (Riok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ceptor (TNFRSF)-interacting serine-threonine kinase 2 (Rip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phingosine kinase 2 (Sphk2), transcript variant 2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rine/threonine kinase 10 (Stk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ousled-like kinase 2 (Arabidopsis) (Tlk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Text Box 5"/>
          <p:cNvSpPr/>
          <p:nvPr/>
        </p:nvSpPr>
        <p:spPr>
          <a:xfrm>
            <a:off x="4320" y="10800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Text Box 15"/>
          <p:cNvSpPr/>
          <p:nvPr/>
        </p:nvSpPr>
        <p:spPr>
          <a:xfrm>
            <a:off x="3139560" y="18900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1" name="Object 5"/>
          <p:cNvGraphicFramePr/>
          <p:nvPr/>
        </p:nvGraphicFramePr>
        <p:xfrm>
          <a:off x="1143000" y="982800"/>
          <a:ext cx="2419200" cy="1028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12" name="Object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43000" y="982800"/>
                    <a:ext cx="2419200" cy="1028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3" name="Object 6"/>
          <p:cNvGraphicFramePr/>
          <p:nvPr/>
        </p:nvGraphicFramePr>
        <p:xfrm>
          <a:off x="1143000" y="2050920"/>
          <a:ext cx="2467080" cy="11430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14" name="Object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43000" y="2050920"/>
                    <a:ext cx="2467080" cy="1143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15" name="Object 7"/>
          <p:cNvGraphicFramePr/>
          <p:nvPr/>
        </p:nvGraphicFramePr>
        <p:xfrm>
          <a:off x="1143000" y="3241800"/>
          <a:ext cx="2562120" cy="32004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116" name="Object 7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1143000" y="3241800"/>
                    <a:ext cx="2562120" cy="3200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17" name="Text Box 11"/>
          <p:cNvSpPr/>
          <p:nvPr/>
        </p:nvSpPr>
        <p:spPr>
          <a:xfrm>
            <a:off x="250200" y="98100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Lig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8" name="Text Box 12"/>
          <p:cNvSpPr/>
          <p:nvPr/>
        </p:nvSpPr>
        <p:spPr>
          <a:xfrm>
            <a:off x="132840" y="2133720"/>
            <a:ext cx="9108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embran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raffic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9" name="Text Box 13"/>
          <p:cNvSpPr/>
          <p:nvPr/>
        </p:nvSpPr>
        <p:spPr>
          <a:xfrm>
            <a:off x="-38520" y="3213000"/>
            <a:ext cx="1252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Oxidoreductas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0" name="Rectangle 10"/>
          <p:cNvSpPr/>
          <p:nvPr/>
        </p:nvSpPr>
        <p:spPr>
          <a:xfrm>
            <a:off x="3645000" y="981000"/>
            <a:ext cx="6107040" cy="109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rgininosuccinate synthetase 1 (Ass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eural precursor cell expressed, developmentally down-regulated gene 4-like (Nedd4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ng finger protein 31 (Rnf3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ipartite motif protein 34 (Trim3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ripartite motif protein 34 (Trim3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activating enzyme E1-like (Ube1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conjugating enzyme E2L 6 (Ube2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-conjugating enzyme E2L 6 (Ube2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biquitin specific peptidase 53 (Usp53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Rectangle 11"/>
          <p:cNvSpPr/>
          <p:nvPr/>
        </p:nvSpPr>
        <p:spPr>
          <a:xfrm>
            <a:off x="3645000" y="2035080"/>
            <a:ext cx="5256000" cy="12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romatin modifying protein 1B (Chmp1b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eroid lipofuscinosis, neuronal 3, juvenile (Batten, Spielmeyer-Vogt disease) (Cln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lathrin, light polypeptide (Lcb) (Clt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GF-regulated tyrosine kinase substrate (Hgs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-ethylmaleimide sensitive fusion protein attachment protein alpha (Nap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SFL1 (p97) cofactor (p47) (Nsfl1c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orting nexin 10 (Snx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yntaxin 11 (Stx1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yntaxin binding protein 2 (Stxbp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vesicle-associated membrane protein 5 (Vamp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2" name="Rectangle 12"/>
          <p:cNvSpPr/>
          <p:nvPr/>
        </p:nvSpPr>
        <p:spPr>
          <a:xfrm>
            <a:off x="3635280" y="3208320"/>
            <a:ext cx="6408720" cy="335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cetyl-Coenzyme A dehydrogenase, long-chain (Acad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cyl-Coenzyme A dehydrogenase, very long chain (Acadv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cyl-Coenzyme A oxidase 2, branched chain (Acox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xpressed sequence AI256775 (AI25677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do-keto reductase family 1, member B10 (aldose reductase) (Akr1b10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dehyde dehydrogenase 1 family, member L2 (Aldh1l2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dehyde dehydrogenase 2, mitochondrial (Aldh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ldehyde dehydrogenase 3 family, member B1 (Aldh3b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iliverdin reductase B (flavin reductase (NADPH)) (Blvr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chrome c oxidase, subunit VI a, polypeptide 2 (Cox6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chrome P450, family 3, subfamily a, polypeptide 13 (Cyp3a1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chrome P450, 51 (Cyp5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ehydrogenase/reductase (SDR family) member 7 (Dhrs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ehydrogenase/reductase (SDR family) member 7 (Dhrs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lutathione reductase 1 (Gsr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ydroxysteroid (17-beta) dehydrogenase 7 (Hsd17b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terferon gamma inducible protein 30 (Ifi3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terferon gamma inducible protein 30 (Ifi3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tochrome b5 reductase 1 (Cyb5r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 Narrow"/>
              </a:rPr>
              <a:t>procollagen-proline, 2-oxoglutarate 4-dioxygenase (proline 4-hydroxylase), alpha II polypeptide (P4ha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collagen lysine, 2-oxoglutarate 5-dioxygenase 2 (Plod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araoxonase 3 (Pon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eroxiredoxin 6 (Prdx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tinol dehydrogenase 11 (Rdh1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terol-C4-methyl oxidase-like (Sc4mo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uperoxide dismutase 1, soluble (So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ioredoxin reductase 1 (Txnrd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xpressed sequence AA467197 (AA46719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3" name="Text Box 5"/>
          <p:cNvSpPr/>
          <p:nvPr/>
        </p:nvSpPr>
        <p:spPr>
          <a:xfrm>
            <a:off x="4320" y="10800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4" name="Text Box 15"/>
          <p:cNvSpPr/>
          <p:nvPr/>
        </p:nvSpPr>
        <p:spPr>
          <a:xfrm>
            <a:off x="3211200" y="18900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5" name="Object 4"/>
          <p:cNvGraphicFramePr/>
          <p:nvPr/>
        </p:nvGraphicFramePr>
        <p:xfrm>
          <a:off x="1298520" y="646200"/>
          <a:ext cx="2752920" cy="3314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26" name="Object 4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298520" y="646200"/>
                    <a:ext cx="2752920" cy="3314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27" name="Object 5"/>
          <p:cNvGraphicFramePr/>
          <p:nvPr/>
        </p:nvGraphicFramePr>
        <p:xfrm>
          <a:off x="1298520" y="4000680"/>
          <a:ext cx="2562120" cy="274320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128" name="Object 5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298520" y="4000680"/>
                    <a:ext cx="2562120" cy="2743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129" name="Text Box 6"/>
          <p:cNvSpPr/>
          <p:nvPr/>
        </p:nvSpPr>
        <p:spPr>
          <a:xfrm>
            <a:off x="324720" y="692280"/>
            <a:ext cx="8604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elect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gulatory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rotein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0" name="Text Box 7"/>
          <p:cNvSpPr/>
          <p:nvPr/>
        </p:nvSpPr>
        <p:spPr>
          <a:xfrm>
            <a:off x="303120" y="4005360"/>
            <a:ext cx="81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ignaling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olecule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1" name="Text Box 15"/>
          <p:cNvSpPr/>
          <p:nvPr/>
        </p:nvSpPr>
        <p:spPr>
          <a:xfrm>
            <a:off x="3211200" y="115920"/>
            <a:ext cx="845280" cy="337320"/>
          </a:xfrm>
          <a:prstGeom prst="rect">
            <a:avLst/>
          </a:prstGeom>
          <a:noFill/>
          <a:ln w="936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132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2" name="Rectangle 10"/>
          <p:cNvSpPr/>
          <p:nvPr/>
        </p:nvSpPr>
        <p:spPr>
          <a:xfrm>
            <a:off x="4035600" y="620640"/>
            <a:ext cx="6178320" cy="347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myotrophic lateral sclerosis 2 (juvenile) homolog (human) (Als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DP-ribosylation factor 2 (Arf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ac/Cdc42 guanine nucleotide exchange factor (GEF) 6 (Arhgef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uanylate nucleotide binding protein 1 (Gb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uanylate binding protein 6 (Gbp6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uanine nucleotide binding protein (G protein), gamma 4 subunit (Gng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TP binding protein 4 (Gtpbp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otassium channel tetramerisation domain containing 6 (Kctd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yeloid differentiation primary response gene 88 (Myd8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ucleosome assembly protein 1-like 1 (Nap1l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uclear factor of kappa light chain gene enhancer in B-cells inhibitor, alpha (Nfkbi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in kinase, AMP-activated, beta 2 non-catalytic subunit (Prkab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saposin (Psap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non-ATPase, 12 (Psmd1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non-ATPase, 13 (Psmd1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non-ATPase, 2 (Psmd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roteasome (prosome, macropain) 26S subunit, non-ATPase, 4 (Psmd4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al GEF with PH domain and SH3 binding motif 1 (Ralgps1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gulator of G-protein signalling 10 (Rgs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gulator of G-protein signaling 12 (Rgs1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as-like without CAAX 1 (Rit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etinal S-antigen (Sag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l1 (suppressor of lin-12) 1 homolog (C. elegans) (Sel1h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erine (or cysteine) proteinase inhibitor, clade B, member 6a (Serpinb6a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-cell activation Rho GTPase-activating protein (Tagap), mRNA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-cell lymphoma invasion and metastasis 1 (Tiam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issue inhibitor of metalloproteinase 3 (Timp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issue inhibitor of metalloproteinase 3 (Timp3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IKEN cDNA 5730410E15 gene (5730410E15Rik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3" name="Rectangle 11"/>
          <p:cNvSpPr/>
          <p:nvPr/>
        </p:nvSpPr>
        <p:spPr>
          <a:xfrm>
            <a:off x="4016520" y="3976560"/>
            <a:ext cx="5976720" cy="2882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rtemin (Artn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rtemin (Artn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emokine (C-C motif) ligand 2 (Ccl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hemokine (C-C motif) ligand 7 (Ccl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ysteine and histidine-rich domain (CHORD)-containing, zinc-binding protein 1 (Chordc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ual adaptor for phosphotyrosine and 3-phosphoinositides 1 (Dap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piregulin (Ereg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26 avian leukemia oncogene 2, 3 domain (Ets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ranulin (Grn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terleukin 15 (Il15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terleukin 7 (Il7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nsulin-like 6 (Insl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kit ligand (Kitl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ctin, galactose binding, soluble 8 (Lgals8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ctin, galactose binding, soluble 9 (Lgals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ectin, galactose binding, soluble 9 (Lgals9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erve growth factor, beta (Ngfb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latelet-derived growth factor,  C polypeptide (Pdgfc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hospholipase C, gamma 2 (Plcg2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rombospondin 1 (Thbs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rombospondin 1 (Thbs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f receptor-associated factor 6 (Traf6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hyroid hormone receptor interactor 10 (Trip10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35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NT1 inducible signaling pathway protein 1 (Wisp1), mRNA.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34" name="Text Box 5"/>
          <p:cNvSpPr/>
          <p:nvPr/>
        </p:nvSpPr>
        <p:spPr>
          <a:xfrm>
            <a:off x="4320" y="108000"/>
            <a:ext cx="263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l Figure 4C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01T08:52:14Z</dcterms:created>
  <dc:creator>김희정</dc:creator>
  <dc:description/>
  <dc:language>en-US</dc:language>
  <cp:lastModifiedBy>김희정</cp:lastModifiedBy>
  <dcterms:modified xsi:type="dcterms:W3CDTF">2011-06-13T06:37:14Z</dcterms:modified>
  <cp:revision>20</cp:revision>
  <dc:subject/>
  <dc:title>슬라이드 1</dc:title>
</cp:coreProperties>
</file>